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50" y="2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6861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1108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3278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5809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06298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2968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279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8122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9485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8819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03829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126ECF-0DAC-4ADF-9523-1BF52478C7BA}" type="datetimeFigureOut">
              <a:rPr lang="en-AU" smtClean="0"/>
              <a:t>15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C13CA-4EE6-41A6-AE31-8FF13155A8F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9927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36045" y="160133"/>
            <a:ext cx="4143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6B</a:t>
            </a:r>
            <a:endParaRPr lang="en-AU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045" y="1904689"/>
            <a:ext cx="4450080" cy="334213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62488" y="570745"/>
            <a:ext cx="51761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Hypothalamus lysates from wild type and ACC DKI mice after leptin treatment</a:t>
            </a:r>
            <a:endParaRPr lang="en-AU" dirty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4154338" y="2861793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>
            <a:off x="4433988" y="4154371"/>
            <a:ext cx="525082" cy="168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986125" y="2592300"/>
            <a:ext cx="141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saline</a:t>
            </a:r>
            <a:endParaRPr lang="en-AU" dirty="0"/>
          </a:p>
        </p:txBody>
      </p:sp>
      <p:sp>
        <p:nvSpPr>
          <p:cNvPr id="10" name="TextBox 9"/>
          <p:cNvSpPr txBox="1"/>
          <p:nvPr/>
        </p:nvSpPr>
        <p:spPr>
          <a:xfrm>
            <a:off x="4986125" y="3919560"/>
            <a:ext cx="141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leptin</a:t>
            </a:r>
            <a:endParaRPr lang="en-AU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00" y="1680944"/>
            <a:ext cx="3681984" cy="3134868"/>
          </a:xfrm>
          <a:prstGeom prst="rect">
            <a:avLst/>
          </a:prstGeom>
        </p:spPr>
      </p:pic>
      <p:cxnSp>
        <p:nvCxnSpPr>
          <p:cNvPr id="12" name="Straight Arrow Connector 11"/>
          <p:cNvCxnSpPr/>
          <p:nvPr/>
        </p:nvCxnSpPr>
        <p:spPr>
          <a:xfrm>
            <a:off x="6094095" y="2776966"/>
            <a:ext cx="61341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5942648" y="4057653"/>
            <a:ext cx="61341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964267" y="1449706"/>
            <a:ext cx="1919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Phospho-STAT3</a:t>
            </a:r>
            <a:endParaRPr lang="en-AU" dirty="0"/>
          </a:p>
        </p:txBody>
      </p:sp>
      <p:sp>
        <p:nvSpPr>
          <p:cNvPr id="15" name="TextBox 14"/>
          <p:cNvSpPr txBox="1"/>
          <p:nvPr/>
        </p:nvSpPr>
        <p:spPr>
          <a:xfrm>
            <a:off x="7975601" y="1449706"/>
            <a:ext cx="1089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STAT3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741020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elbour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ra galic</dc:creator>
  <cp:lastModifiedBy>Sandra galic</cp:lastModifiedBy>
  <cp:revision>1</cp:revision>
  <dcterms:created xsi:type="dcterms:W3CDTF">2018-01-15T03:49:33Z</dcterms:created>
  <dcterms:modified xsi:type="dcterms:W3CDTF">2018-01-15T03:51:21Z</dcterms:modified>
</cp:coreProperties>
</file>